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186B20-FC63-4D30-AAFA-4AA70649F3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0937A0C-ECF3-4892-A147-057FB81551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6E15405-8948-43DA-A2E8-DA13729E4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2BFD89-A777-4C0C-8318-280997843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30AE3BA-164C-445E-A3A4-071E7231F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191560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C49FE1-6E70-431A-9434-8D1889937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BC945A1-DA91-454E-9FF2-1A111AD723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F6D49EA-0EEC-4C37-9E7D-F1E2FEF7D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720D9EE-FAE5-4DF0-AE2F-CCFDCCF08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DD627F7-39A2-489A-A59D-75FEB63AD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4352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EEB5BBA-BB18-46F5-B366-6D8DC23054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9247311-3A55-4D5A-9F96-6291B79CAE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49E5481-6297-4510-A55E-7F63E63D2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67FAE16-BA7C-4997-989C-619B3735A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52C21EB-52FB-459A-91D2-0F884032F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1897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E770006-BFC5-4486-82E2-3914E9CD22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0E40946-7B00-4C96-894D-872E90B027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654F00A-0EF4-4EE0-9553-D0FE2772F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71151E0-D31B-49E5-98B3-9245D0F34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D323AC6-CDC5-4832-B54A-C73A5FBDF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3002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C7A0DF-44C2-4A08-847B-D63FAFE587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A2F4385-7539-49B7-8D22-0FE489D2EA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7F79EF6-DD17-421B-8562-EE17C1DF4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97DD713-C62A-42B3-AE06-7B45954B0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622D5A0-1D48-41DC-A202-A387F3FC6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6091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E40A25-89BD-4C40-A534-870C55B32C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32EBC71-EFFC-4C5D-952F-EFEC365FF1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0C6556A-EC72-4C98-9369-C3285A6DCF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AB3A85D-F8DA-43E1-A4A8-C77453A8F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260D002-0C6B-469E-A97D-409E8C441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4EBADFC-1E01-4084-A7C7-069FBEB07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786967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BED5ED-C31B-4F34-BEEC-BD4F36FCC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DFAC210-9410-4EAC-861B-9E56CD3D4C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DC50223-8897-47C4-8978-E8BD480014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CBB75F9-7D46-45CE-933E-1BCA4417D6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A82AEB8-A587-4D18-9296-C5E44C745D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96EE671D-D95E-4114-95F5-5642C5E46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DA6A505-D311-44F4-B548-32DC77730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4F373DB-CB09-412B-8947-FAEE23E74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11677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8F9A8F-5474-493F-BEBB-49B8194130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F17F961-0BBE-4B6F-AC72-B0B251FD2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BB2E2F1-77C4-4AD5-930B-3BA51A287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4E19533-076B-4E92-B8A2-9642E25C4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38384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46CD426-84B5-407E-A1CA-CBB97A2A7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12E2EC2-DF40-43DD-8612-58ECED92A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2CED43D-19EC-41D4-BE38-2E8B5D84A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9053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BD016A-0F8D-443A-A6B3-58C8409A8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533E1B4-2C5B-4DD7-91C3-DF1841F473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069B898-B902-4DC3-807B-5F0AB91DB3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E7111B9-ACCB-4134-BCCE-2E46CEAAB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0BC395D-AB18-40F7-B3C5-6F892F28C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90B03DE-3B04-4D3E-A073-A0D87DC54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26399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281FA4B-A3BA-46B6-9912-29C745BAA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B86ED0F-6BBF-4EAA-866D-3AD020E667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7F0D51A-C51C-4F58-A9E5-9875F0F26A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9A9C320-4285-40E3-8932-E8D857F92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4320068-DD86-443A-9F51-C1F147A23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B2A946D-85F0-4A57-8F57-E81D0749A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112587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2E06F99-DDC3-4302-8CF5-20A238F57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B3C17DA-C123-49AB-8335-6047708109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0297D84-F19C-462E-ADEA-2803810431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3CD781-4ED6-4D4A-816C-F1CB05A4ED44}" type="datetimeFigureOut">
              <a:rPr lang="es-CO" smtClean="0"/>
              <a:pPr/>
              <a:t>15/04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768EA36-E859-40BE-8503-B980484E42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F951ACB-E84F-4687-BD0E-52CB39BEB1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6365EA-DD70-437D-8180-F8F747DC1787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429564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e 27"/>
          <p:cNvGrpSpPr/>
          <p:nvPr/>
        </p:nvGrpSpPr>
        <p:grpSpPr>
          <a:xfrm>
            <a:off x="8680879" y="922264"/>
            <a:ext cx="2834162" cy="2562539"/>
            <a:chOff x="6666088" y="319065"/>
            <a:chExt cx="2834162" cy="2562539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 cstate="print"/>
            <a:srcRect l="13557" t="14960" b="52772"/>
            <a:stretch/>
          </p:blipFill>
          <p:spPr>
            <a:xfrm rot="16200000">
              <a:off x="6185454" y="1241039"/>
              <a:ext cx="2089423" cy="1128156"/>
            </a:xfrm>
            <a:prstGeom prst="rect">
              <a:avLst/>
            </a:prstGeom>
          </p:spPr>
        </p:pic>
        <p:sp>
          <p:nvSpPr>
            <p:cNvPr id="19" name="ZoneTexte 18"/>
            <p:cNvSpPr txBox="1"/>
            <p:nvPr/>
          </p:nvSpPr>
          <p:spPr>
            <a:xfrm>
              <a:off x="6797105" y="493603"/>
              <a:ext cx="81304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Xoc</a:t>
              </a:r>
              <a:r>
                <a:rPr lang="fr-FR" sz="1050" dirty="0"/>
                <a:t> BLS256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6823562" y="319065"/>
              <a:ext cx="2676688" cy="2668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/>
                <a:t>ZBED 1/0                         ZBED 1OX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8143970" y="478449"/>
              <a:ext cx="81304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Xoc</a:t>
              </a:r>
              <a:r>
                <a:rPr lang="fr-FR" sz="1050" dirty="0"/>
                <a:t> BLS256</a:t>
              </a:r>
            </a:p>
          </p:txBody>
        </p:sp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2" cstate="print"/>
            <a:srcRect l="8022" t="52075" r="4775" b="20027"/>
            <a:stretch/>
          </p:blipFill>
          <p:spPr>
            <a:xfrm rot="16200000">
              <a:off x="7601538" y="1311360"/>
              <a:ext cx="2121200" cy="1019287"/>
            </a:xfrm>
            <a:prstGeom prst="rect">
              <a:avLst/>
            </a:prstGeom>
          </p:spPr>
        </p:pic>
      </p:grpSp>
      <p:sp>
        <p:nvSpPr>
          <p:cNvPr id="31" name="ZoneTexte 30"/>
          <p:cNvSpPr txBox="1"/>
          <p:nvPr/>
        </p:nvSpPr>
        <p:spPr>
          <a:xfrm>
            <a:off x="168451" y="910228"/>
            <a:ext cx="3658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A)</a:t>
            </a:r>
          </a:p>
        </p:txBody>
      </p:sp>
      <p:sp>
        <p:nvSpPr>
          <p:cNvPr id="32" name="ZoneTexte 31"/>
          <p:cNvSpPr txBox="1"/>
          <p:nvPr/>
        </p:nvSpPr>
        <p:spPr>
          <a:xfrm>
            <a:off x="4332789" y="910228"/>
            <a:ext cx="3593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B)</a:t>
            </a:r>
          </a:p>
        </p:txBody>
      </p:sp>
      <p:grpSp>
        <p:nvGrpSpPr>
          <p:cNvPr id="42" name="41 Grupo"/>
          <p:cNvGrpSpPr/>
          <p:nvPr/>
        </p:nvGrpSpPr>
        <p:grpSpPr>
          <a:xfrm>
            <a:off x="457694" y="922265"/>
            <a:ext cx="2687199" cy="2565659"/>
            <a:chOff x="148944" y="577713"/>
            <a:chExt cx="2687199" cy="2565659"/>
          </a:xfrm>
        </p:grpSpPr>
        <p:grpSp>
          <p:nvGrpSpPr>
            <p:cNvPr id="16" name="Groupe 15"/>
            <p:cNvGrpSpPr/>
            <p:nvPr/>
          </p:nvGrpSpPr>
          <p:grpSpPr>
            <a:xfrm>
              <a:off x="430753" y="577713"/>
              <a:ext cx="2098651" cy="453841"/>
              <a:chOff x="7482350" y="43550"/>
              <a:chExt cx="1839455" cy="425313"/>
            </a:xfrm>
          </p:grpSpPr>
          <p:sp>
            <p:nvSpPr>
              <p:cNvPr id="14" name="ZoneTexte 13"/>
              <p:cNvSpPr txBox="1"/>
              <p:nvPr/>
            </p:nvSpPr>
            <p:spPr>
              <a:xfrm>
                <a:off x="7490993" y="43550"/>
                <a:ext cx="1798710" cy="245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/>
                  <a:t>ZBED 1/0                      ZBED 1OX</a:t>
                </a:r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7482350" y="230908"/>
                <a:ext cx="1839455" cy="2379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dirty="0" err="1"/>
                  <a:t>Xoo</a:t>
                </a:r>
                <a:r>
                  <a:rPr lang="fr-FR" sz="1050" dirty="0"/>
                  <a:t> PXO99A                  </a:t>
                </a:r>
                <a:r>
                  <a:rPr lang="fr-FR" sz="1050" dirty="0" err="1"/>
                  <a:t>Xoo</a:t>
                </a:r>
                <a:r>
                  <a:rPr lang="fr-FR" sz="1050" dirty="0"/>
                  <a:t> PXO99A</a:t>
                </a:r>
              </a:p>
            </p:txBody>
          </p:sp>
        </p:grpSp>
        <p:pic>
          <p:nvPicPr>
            <p:cNvPr id="33" name="Image 3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944" y="1031554"/>
              <a:ext cx="1352431" cy="2111818"/>
            </a:xfrm>
            <a:prstGeom prst="rect">
              <a:avLst/>
            </a:prstGeom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4001" y="977102"/>
              <a:ext cx="1282142" cy="2151116"/>
            </a:xfrm>
            <a:prstGeom prst="rect">
              <a:avLst/>
            </a:prstGeom>
          </p:spPr>
        </p:pic>
      </p:grp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380214" y="3883059"/>
            <a:ext cx="3055462" cy="18351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5904" y="3883059"/>
            <a:ext cx="3069110" cy="1847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9" name="ZoneTexte 31"/>
          <p:cNvSpPr txBox="1"/>
          <p:nvPr/>
        </p:nvSpPr>
        <p:spPr>
          <a:xfrm>
            <a:off x="8393245" y="910228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C)</a:t>
            </a:r>
          </a:p>
        </p:txBody>
      </p:sp>
      <p:grpSp>
        <p:nvGrpSpPr>
          <p:cNvPr id="41" name="40 Grupo"/>
          <p:cNvGrpSpPr/>
          <p:nvPr/>
        </p:nvGrpSpPr>
        <p:grpSpPr>
          <a:xfrm>
            <a:off x="4622529" y="924539"/>
            <a:ext cx="2530141" cy="2543223"/>
            <a:chOff x="3280570" y="579987"/>
            <a:chExt cx="2530141" cy="2543223"/>
          </a:xfrm>
        </p:grpSpPr>
        <p:pic>
          <p:nvPicPr>
            <p:cNvPr id="1031" name="Picture 7" descr="C:\Users\Paolinda_2\Desktop\Paola Files\Experiments\PZ10_ZBED_Xoo\Rep2photos\ZBEDOX3_Xoo.jpg"/>
            <p:cNvPicPr>
              <a:picLocks noChangeAspect="1" noChangeArrowheads="1"/>
            </p:cNvPicPr>
            <p:nvPr/>
          </p:nvPicPr>
          <p:blipFill>
            <a:blip r:embed="rId7" cstate="print"/>
            <a:srcRect l="47019" t="58864" r="3362" b="15473"/>
            <a:stretch>
              <a:fillRect/>
            </a:stretch>
          </p:blipFill>
          <p:spPr bwMode="auto">
            <a:xfrm rot="16200000">
              <a:off x="4106382" y="1418880"/>
              <a:ext cx="2098478" cy="1310181"/>
            </a:xfrm>
            <a:prstGeom prst="rect">
              <a:avLst/>
            </a:prstGeom>
            <a:noFill/>
          </p:spPr>
        </p:pic>
        <p:sp>
          <p:nvSpPr>
            <p:cNvPr id="36" name="ZoneTexte 19"/>
            <p:cNvSpPr txBox="1"/>
            <p:nvPr/>
          </p:nvSpPr>
          <p:spPr>
            <a:xfrm>
              <a:off x="3454736" y="579987"/>
              <a:ext cx="20726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/>
                <a:t>ZBED 1/0                       ZBED 1OX</a:t>
              </a:r>
            </a:p>
          </p:txBody>
        </p:sp>
        <p:sp>
          <p:nvSpPr>
            <p:cNvPr id="37" name="ZoneTexte 21"/>
            <p:cNvSpPr txBox="1"/>
            <p:nvPr/>
          </p:nvSpPr>
          <p:spPr>
            <a:xfrm>
              <a:off x="4760960" y="739372"/>
              <a:ext cx="6703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Xoo</a:t>
              </a:r>
              <a:r>
                <a:rPr lang="fr-FR" sz="1050" dirty="0"/>
                <a:t> </a:t>
              </a:r>
              <a:r>
                <a:rPr lang="fr-FR" sz="1050" dirty="0" err="1"/>
                <a:t>MaiI</a:t>
              </a:r>
              <a:endParaRPr lang="fr-FR" sz="1050" dirty="0"/>
            </a:p>
          </p:txBody>
        </p:sp>
        <p:sp>
          <p:nvSpPr>
            <p:cNvPr id="38" name="ZoneTexte 21"/>
            <p:cNvSpPr txBox="1"/>
            <p:nvPr/>
          </p:nvSpPr>
          <p:spPr>
            <a:xfrm>
              <a:off x="3481392" y="741644"/>
              <a:ext cx="6703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/>
                <a:t>Xoo</a:t>
              </a:r>
              <a:r>
                <a:rPr lang="fr-FR" sz="1050" dirty="0"/>
                <a:t> </a:t>
              </a:r>
              <a:r>
                <a:rPr lang="fr-FR" sz="1050" dirty="0" err="1"/>
                <a:t>MaiI</a:t>
              </a:r>
              <a:endParaRPr lang="fr-FR" sz="1050" dirty="0"/>
            </a:p>
          </p:txBody>
        </p:sp>
        <p:pic>
          <p:nvPicPr>
            <p:cNvPr id="1032" name="Picture 8" descr="C:\Users\Paolinda_2\Desktop\Paola Files\Experiments\PZ10_ZBED_Xoo\Rep2photos\ZBED3_Azyg_Xoo.jpg"/>
            <p:cNvPicPr>
              <a:picLocks noChangeAspect="1" noChangeArrowheads="1"/>
            </p:cNvPicPr>
            <p:nvPr/>
          </p:nvPicPr>
          <p:blipFill>
            <a:blip r:embed="rId8" cstate="print"/>
            <a:srcRect l="42734" t="69394" b="7045"/>
            <a:stretch>
              <a:fillRect/>
            </a:stretch>
          </p:blipFill>
          <p:spPr bwMode="auto">
            <a:xfrm rot="16200000">
              <a:off x="2806542" y="1498759"/>
              <a:ext cx="2086603" cy="1138548"/>
            </a:xfrm>
            <a:prstGeom prst="rect">
              <a:avLst/>
            </a:prstGeom>
            <a:noFill/>
          </p:spPr>
        </p:pic>
      </p:grp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8573181" y="3883059"/>
            <a:ext cx="3048819" cy="18351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9" name="CuadroTexto 28">
            <a:extLst>
              <a:ext uri="{FF2B5EF4-FFF2-40B4-BE49-F238E27FC236}">
                <a16:creationId xmlns:a16="http://schemas.microsoft.com/office/drawing/2014/main" id="{FBCDC370-B11C-46A1-BD04-9650BC569E06}"/>
              </a:ext>
            </a:extLst>
          </p:cNvPr>
          <p:cNvSpPr txBox="1"/>
          <p:nvPr/>
        </p:nvSpPr>
        <p:spPr>
          <a:xfrm>
            <a:off x="9606837" y="297586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err="1"/>
              <a:t>Supplemental</a:t>
            </a:r>
            <a:r>
              <a:rPr lang="es-MX" dirty="0"/>
              <a:t> </a:t>
            </a:r>
            <a:r>
              <a:rPr lang="es-MX"/>
              <a:t>Figure 3</a:t>
            </a:r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2632864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Panorámica</PresentationFormat>
  <Paragraphs>1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drea Paola Zuluaga Cruz</dc:creator>
  <cp:lastModifiedBy>Andrea Paola Zuluaga Cruz</cp:lastModifiedBy>
  <cp:revision>3</cp:revision>
  <dcterms:created xsi:type="dcterms:W3CDTF">2019-03-11T15:06:33Z</dcterms:created>
  <dcterms:modified xsi:type="dcterms:W3CDTF">2020-04-15T10:27:06Z</dcterms:modified>
</cp:coreProperties>
</file>